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26067-9569-4D9D-A38F-64CAA70AFA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7E647-4D06-4592-9880-D63601AFBE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DAF04-3979-4B76-BE98-DF5BFEE786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3A4EF-2279-4C2D-9D0B-A907189CD6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22299-1CD6-4776-9324-D0C6B97885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52B81-D1B0-4FA8-8378-C526D5FCBB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E441D-C087-4B4F-BBA1-21433DC502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34B55-A42F-421B-B6B5-013064B533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E9F32-CB1C-469F-91A5-BD95BA86F1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DA018-8459-4125-8D5C-AD1ACAF818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E1CBE-8EB8-4222-A24C-CC758B516C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5296F-7DC6-430F-B2CB-1954D9EAAD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FCD006-AE19-4C58-ACA2-477DA371C96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5920" y="345960"/>
          <a:ext cx="6553080" cy="7893000"/>
        </p:xfrm>
        <a:graphic>
          <a:graphicData uri="http://schemas.openxmlformats.org/drawingml/2006/table">
            <a:tbl>
              <a:tblPr/>
              <a:tblGrid>
                <a:gridCol w="649080"/>
                <a:gridCol w="2702160"/>
                <a:gridCol w="3201840"/>
              </a:tblGrid>
              <a:tr h="255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dicted targ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tative function of targ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29833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 binding / DNA-directed RNA polymer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286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71796_T01; GRMZM2G355906_T03; GRMZM2G355906_T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sphofructokinase, putative; glutamate decarboxylase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35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53298_T01; GRMZM2G053298_T02; GRMZM2G466549_T02; GRMZM2G140085_T01; GRMZM2G140085_T0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WP-RK domain-containing protein; GRAS family transcription factor containing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01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o, miR171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00039_T01 ; GRMZM2G304956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T4 phosphatase-associated family protein; regulatory protein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84248_T01; GRMZM2G318689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ucine-rich repeat transmembrane protein kinase, putative; ethylene receptor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15605.2_FGT00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press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86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77110_T01; GRMZM2G467356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UF260 domain containing protein, putative; ferredoxin 1-like isoform 1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334899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ulin/FtsZ domain containing protein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44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00686_T01; GRMZM2G000686_T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00686_T03; GRMZM2G000686_T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00686_T05; GRMZM2G000686_T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00686_T07; GRMZM2G000686_T08 GRMZM2G000686_T09; GRMZM2G000686_T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65488_T01; GRMZM2G165488_T0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65488_T03; GRMZM2G165488_T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91964_T01; GRMZM2G091964_T0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91964_T03; GRMZM2G078124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418749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clear transcription factor Y subunit; pentatricopeptide (PPR) repeat-containing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588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42347_T01; GRMZM2G056335_T01; GRMZM2G071304_T01; GRMZM2G084942_T01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84942_T02; GRMZM2G088753_T01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405022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roxidase, putative; cytokinin-O-glucosyltransferase 1, putative; LIG1-putative DNA ligase I; arogenate dehydrogenase 1; 1,4-alpha-glucan-branching enzyme; GDU1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35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398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194259.3_FGT001; GRMZM2G068519_T01; GRMZM2G068519_T02; GRMZM2G162233_T01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62233_T02; GRMZM2G455075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pressed protein; UDP-glucoronosyl and UDP-glucosyl transferase domain containing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52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194587.2_FGT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cloartenol synthase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307567_T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R4-Not complex component, Not1domain containing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527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q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34201.1_FGT003; GRMZM2G011947_T01; GRMZM2G037792_T01; GRMZM2G051785_T01; GRMZM2G060265_T01; GRMZM2G079470_T01; GRMZM2G079980_T01; GRMZM2G098800_T01; GRMZM2G098800_T02; GRMZM2G106748_T01; GRMZM2G111191_T01; GRMZM2G111191_T02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418899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nylcysteine oxidase 1 precursor, putative; scarecrow, putative; lipoxygenase, putative; zinc finger family protein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67253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ceptor-like protein kinase HAIKU2 precursor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39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04517.3_FGT002; GRMZM2G137037_T01; GRMZM2G137037_T02; GRMZM2G175995_T01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360081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D dependent oxidoreductase, putative; expressed protein; transcription factor binding / ubiquitin-protein lig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83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16801.3_FGT003; GRMZM2G031326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 binding / transcription coactivator; nucleolar complex protein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61"/>
          <p:cNvSpPr/>
          <p:nvPr/>
        </p:nvSpPr>
        <p:spPr>
          <a:xfrm>
            <a:off x="414000" y="90360"/>
            <a:ext cx="602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dicted targets of novel miRNAs identified by small RNA deep sequencing in maiz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115920" y="345960"/>
          <a:ext cx="6553080" cy="2395800"/>
        </p:xfrm>
        <a:graphic>
          <a:graphicData uri="http://schemas.openxmlformats.org/drawingml/2006/table">
            <a:tbl>
              <a:tblPr/>
              <a:tblGrid>
                <a:gridCol w="649080"/>
                <a:gridCol w="2702160"/>
                <a:gridCol w="3201840"/>
              </a:tblGrid>
              <a:tr h="258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dicted targ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utative function of targ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39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30823_T01; GRMZM2G030823_T02 ; GRMZM2G030823_T03; GRMZM2G090152_T02; GRMZM2G390678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, LRR and FBD domain containing protein; unknown protein; GDSL-like lipase/acylhydrolase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9874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45421_T01; GRMZM2G102174_T01; GRMZM2G102174_T02; GRMZM2G115390_T01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15390_T02; GRMZM2G115390_T03;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15390_T04; GRMZM2G115390_T05; GRMZM2G149175_T01; GRMZM2G149175_T03; GRMZM2G149175_T06 ; GRMZM2G369939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WWP domain containing protein; PWWP domain containing protein, expressed; unknown protein; eIF-5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39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030823_T01; GRMZM2G030823_T02; GRMZM2G030823_T03; GRMZM2G061339_T01; GRMZM2G399048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, LRR and FBD domain containing protein, expressed; glycosyltransferase sugar-binding region containing DXD motif, putat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8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MZM2G123805_T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pase/ nutrient reservoi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矩形 4"/>
          <p:cNvSpPr/>
          <p:nvPr/>
        </p:nvSpPr>
        <p:spPr>
          <a:xfrm>
            <a:off x="89640" y="119160"/>
            <a:ext cx="131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3. continu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1T08:40:40Z</dcterms:created>
  <dc:creator>MC SYSTEM</dc:creator>
  <dc:description/>
  <dc:language>en-US</dc:language>
  <cp:lastModifiedBy>MC SYSTEM</cp:lastModifiedBy>
  <dcterms:modified xsi:type="dcterms:W3CDTF">2011-10-09T02:53:46Z</dcterms:modified>
  <cp:revision>52</cp:revision>
  <dc:subject/>
  <dc:title>幻灯片 1</dc:title>
</cp:coreProperties>
</file>